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3" r:id="rId2"/>
  </p:sldIdLst>
  <p:sldSz cx="9144000" cy="6858000" type="screen4x3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3825" autoAdjust="0"/>
  </p:normalViewPr>
  <p:slideViewPr>
    <p:cSldViewPr snapToGrid="0">
      <p:cViewPr varScale="1">
        <p:scale>
          <a:sx n="89" d="100"/>
          <a:sy n="89" d="100"/>
        </p:scale>
        <p:origin x="1238" y="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F9A849-7A96-46F8-8471-6F6EABB0C732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43013"/>
            <a:ext cx="447675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86362"/>
            <a:ext cx="5486400" cy="391611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90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90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11D096-BE11-4F33-B0D0-8B236AC794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00484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90625" y="1243013"/>
            <a:ext cx="4476750" cy="3357562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424049-8A59-4FA5-B83E-D370A7EAEB6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97851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347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085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210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9056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095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613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618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6592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813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014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2474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AACC4-62E4-43CD-A33C-9DD4C63F3159}" type="datetimeFigureOut">
              <a:rPr kumimoji="1" lang="ja-JP" altLang="en-US" smtClean="0"/>
              <a:t>2023/3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C0A8BB-7AD3-47DB-AB3B-E2462812D7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185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object 2">
            <a:extLst>
              <a:ext uri="{FF2B5EF4-FFF2-40B4-BE49-F238E27FC236}">
                <a16:creationId xmlns:a16="http://schemas.microsoft.com/office/drawing/2014/main" id="{F1B5D985-4FE5-4AEF-B3CC-C7ECC54AF8D7}"/>
              </a:ext>
            </a:extLst>
          </p:cNvPr>
          <p:cNvSpPr txBox="1"/>
          <p:nvPr/>
        </p:nvSpPr>
        <p:spPr>
          <a:xfrm>
            <a:off x="48430" y="20061"/>
            <a:ext cx="1445883" cy="3821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400" spc="-25" dirty="0">
                <a:latin typeface="Arial" panose="020B0604020202020204" pitchFamily="34" charset="0"/>
                <a:cs typeface="Arial" panose="020B0604020202020204" pitchFamily="34" charset="0"/>
              </a:rPr>
              <a:t>Fi</a:t>
            </a:r>
            <a:r>
              <a:rPr sz="2400" spc="-2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2400" spc="-20" dirty="0">
                <a:latin typeface="Arial" panose="020B0604020202020204" pitchFamily="34" charset="0"/>
                <a:cs typeface="Arial" panose="020B0604020202020204" pitchFamily="34" charset="0"/>
              </a:rPr>
              <a:t>ure S2</a:t>
            </a:r>
            <a:r>
              <a:rPr sz="2400" spc="-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AD662A5B-B171-D95E-07BB-97F03A1DCA95}"/>
              </a:ext>
            </a:extLst>
          </p:cNvPr>
          <p:cNvGrpSpPr/>
          <p:nvPr/>
        </p:nvGrpSpPr>
        <p:grpSpPr>
          <a:xfrm>
            <a:off x="-15843" y="368755"/>
            <a:ext cx="9266098" cy="6643900"/>
            <a:chOff x="-15843" y="368755"/>
            <a:chExt cx="9266098" cy="6643900"/>
          </a:xfrm>
        </p:grpSpPr>
        <p:grpSp>
          <p:nvGrpSpPr>
            <p:cNvPr id="2" name="図形グループ 1"/>
            <p:cNvGrpSpPr/>
            <p:nvPr/>
          </p:nvGrpSpPr>
          <p:grpSpPr>
            <a:xfrm>
              <a:off x="0" y="4657546"/>
              <a:ext cx="8924328" cy="1852613"/>
              <a:chOff x="171609" y="4351367"/>
              <a:chExt cx="8924328" cy="1852613"/>
            </a:xfrm>
          </p:grpSpPr>
          <p:pic>
            <p:nvPicPr>
              <p:cNvPr id="11" name="図 10">
                <a:extLst>
                  <a:ext uri="{FF2B5EF4-FFF2-40B4-BE49-F238E27FC236}">
                    <a16:creationId xmlns:a16="http://schemas.microsoft.com/office/drawing/2014/main" id="{15CE3FCA-B963-480A-8497-9E156C3FDB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59934" y="4351367"/>
                <a:ext cx="5440323" cy="1852613"/>
              </a:xfrm>
              <a:prstGeom prst="rect">
                <a:avLst/>
              </a:prstGeom>
            </p:spPr>
          </p:pic>
          <p:sp>
            <p:nvSpPr>
              <p:cNvPr id="53" name="テキスト ボックス 24">
                <a:extLst>
                  <a:ext uri="{FF2B5EF4-FFF2-40B4-BE49-F238E27FC236}">
                    <a16:creationId xmlns:a16="http://schemas.microsoft.com/office/drawing/2014/main" id="{5E06F0B7-5A6D-4BBE-9E17-7C55D86F7C2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1609" y="4968930"/>
                <a:ext cx="1160035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 </a:t>
                </a:r>
                <a:r>
                  <a:rPr lang="en-US" altLang="ja-JP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---</a:t>
                </a:r>
              </a:p>
            </p:txBody>
          </p:sp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574EAC90-EB04-464C-93A0-8492090D8A9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955117" y="4947415"/>
                <a:ext cx="214082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36 </a:t>
                </a:r>
                <a:r>
                  <a:rPr lang="en-US" altLang="ja-JP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GAPDH</a:t>
                </a:r>
              </a:p>
            </p:txBody>
          </p:sp>
        </p:grpSp>
        <p:pic>
          <p:nvPicPr>
            <p:cNvPr id="3" name="図 2" descr="物体 が含まれている画像&#10;&#10;自動的に生成された説明">
              <a:extLst>
                <a:ext uri="{FF2B5EF4-FFF2-40B4-BE49-F238E27FC236}">
                  <a16:creationId xmlns:a16="http://schemas.microsoft.com/office/drawing/2014/main" id="{5AE459C9-0919-4E66-8DAA-47A1CF4961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964"/>
            <a:stretch/>
          </p:blipFill>
          <p:spPr>
            <a:xfrm>
              <a:off x="1072183" y="368755"/>
              <a:ext cx="5440623" cy="1513831"/>
            </a:xfrm>
            <a:prstGeom prst="rect">
              <a:avLst/>
            </a:prstGeom>
          </p:spPr>
        </p:pic>
        <p:sp>
          <p:nvSpPr>
            <p:cNvPr id="49" name="テキスト ボックス 24">
              <a:extLst>
                <a:ext uri="{FF2B5EF4-FFF2-40B4-BE49-F238E27FC236}">
                  <a16:creationId xmlns:a16="http://schemas.microsoft.com/office/drawing/2014/main" id="{B908AED1-8EFD-471F-92BA-D85FABC6A8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843" y="1421202"/>
              <a:ext cx="116693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ja-JP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---</a:t>
              </a:r>
            </a:p>
          </p:txBody>
        </p:sp>
        <p:sp>
          <p:nvSpPr>
            <p:cNvPr id="50" name="テキスト ボックス 24">
              <a:extLst>
                <a:ext uri="{FF2B5EF4-FFF2-40B4-BE49-F238E27FC236}">
                  <a16:creationId xmlns:a16="http://schemas.microsoft.com/office/drawing/2014/main" id="{64011867-A943-41E6-8101-E3DF6FCEB2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15843" y="445625"/>
              <a:ext cx="117498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r>
                <a:rPr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1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---</a:t>
              </a: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4C4DF0AF-ECAF-4FAC-9B2B-5091460307C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96972" y="943052"/>
              <a:ext cx="2250576" cy="5232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60 </a:t>
              </a:r>
              <a:r>
                <a:rPr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phospho-Akt</a:t>
              </a:r>
            </a:p>
            <a:p>
              <a:pPr eaLnBrk="1" hangingPunct="1"/>
              <a:r>
                <a: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(Ser473)</a:t>
              </a: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324D26A6-CECD-4D09-B6E5-6BB8DEF9ED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675831" y="6300123"/>
              <a:ext cx="108651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HUVEC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5E38407C-7752-4467-8355-6FD3358870C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1951129" y="6095661"/>
              <a:ext cx="5174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7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31F4A47B-84D6-4193-B4C7-D2EB1223E7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2355813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10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1F364299-EBAE-4D69-A3C9-E6C8C29F86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2775501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14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CE595F20-7D47-491B-9CD4-895060CBE28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3177894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16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949CD77B-74E5-4F00-93E8-B0D0F1AFC7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3601001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15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38F3E459-320F-4297-A6AE-CB22FAD02CA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4032203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17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86179DB6-F946-47D0-A3A0-A52F60835C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4446327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18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E4F6CAB0-605D-4E8D-8EA0-A948B16A35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4862061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20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BE33FF0F-B9D2-4883-9567-9C932EA65F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5265607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19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D5FDB593-7F21-40FB-9D76-6A3B5B99B6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843695">
              <a:off x="5688145" y="6118369"/>
              <a:ext cx="58064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r" eaLnBrk="1" hangingPunct="1"/>
              <a:r>
                <a:rPr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21</a:t>
              </a:r>
              <a:endPara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図形グループ 4"/>
            <p:cNvGrpSpPr/>
            <p:nvPr/>
          </p:nvGrpSpPr>
          <p:grpSpPr>
            <a:xfrm>
              <a:off x="740664" y="1969344"/>
              <a:ext cx="8509591" cy="2640721"/>
              <a:chOff x="938359" y="2214602"/>
              <a:chExt cx="8509591" cy="2640721"/>
            </a:xfrm>
          </p:grpSpPr>
          <p:pic>
            <p:nvPicPr>
              <p:cNvPr id="29" name="図 28" descr="室内 が含まれている画像&#10;&#10;自動的に生成された説明">
                <a:extLst>
                  <a:ext uri="{FF2B5EF4-FFF2-40B4-BE49-F238E27FC236}">
                    <a16:creationId xmlns:a16="http://schemas.microsoft.com/office/drawing/2014/main" id="{AFFF086F-7C05-41D4-9F53-7B3C811427B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21815"/>
              <a:stretch/>
            </p:blipFill>
            <p:spPr>
              <a:xfrm>
                <a:off x="2179031" y="2214602"/>
                <a:ext cx="4603335" cy="2640721"/>
              </a:xfrm>
              <a:prstGeom prst="rect">
                <a:avLst/>
              </a:prstGeom>
            </p:spPr>
          </p:pic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2F4FDFB0-BEAE-4946-B8E9-36C68A7E06F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980526" y="3437995"/>
                <a:ext cx="2467424" cy="5232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40 </a:t>
                </a:r>
                <a:r>
                  <a:rPr lang="en-US" altLang="ja-JP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phospho-</a:t>
                </a:r>
                <a:r>
                  <a:rPr lang="en-US" altLang="ja-JP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NOS</a:t>
                </a:r>
                <a:endParaRPr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eaLnBrk="1" hangingPunct="1"/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     </a:t>
                </a:r>
                <a:r>
                  <a:rPr lang="ja-JP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　</a:t>
                </a:r>
                <a:r>
                  <a:rPr lang="en-US" altLang="ja-JP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Ser1177)</a:t>
                </a:r>
              </a:p>
            </p:txBody>
          </p:sp>
          <p:sp>
            <p:nvSpPr>
              <p:cNvPr id="31" name="テキスト ボックス 24">
                <a:extLst>
                  <a:ext uri="{FF2B5EF4-FFF2-40B4-BE49-F238E27FC236}">
                    <a16:creationId xmlns:a16="http://schemas.microsoft.com/office/drawing/2014/main" id="{424FE5EC-E54C-45CC-A4EF-4AC8790D1C7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38359" y="4167368"/>
                <a:ext cx="1338011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 </a:t>
                </a:r>
                <a:r>
                  <a:rPr lang="en-US" altLang="ja-JP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---</a:t>
                </a:r>
              </a:p>
            </p:txBody>
          </p:sp>
          <p:sp>
            <p:nvSpPr>
              <p:cNvPr id="32" name="テキスト ボックス 24">
                <a:extLst>
                  <a:ext uri="{FF2B5EF4-FFF2-40B4-BE49-F238E27FC236}">
                    <a16:creationId xmlns:a16="http://schemas.microsoft.com/office/drawing/2014/main" id="{76886F97-CD45-4F1D-B018-5BD94D04D42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38359" y="3184625"/>
                <a:ext cx="1335068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0 </a:t>
                </a:r>
                <a:r>
                  <a:rPr lang="en-US" altLang="ja-JP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---</a:t>
                </a:r>
              </a:p>
            </p:txBody>
          </p:sp>
          <p:sp>
            <p:nvSpPr>
              <p:cNvPr id="33" name="テキスト ボックス 24">
                <a:extLst>
                  <a:ext uri="{FF2B5EF4-FFF2-40B4-BE49-F238E27FC236}">
                    <a16:creationId xmlns:a16="http://schemas.microsoft.com/office/drawing/2014/main" id="{D2226120-785C-48E5-9A65-637CD93D670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38359" y="2346208"/>
                <a:ext cx="1308474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ＭＳ Ｐゴシック" charset="-128"/>
                  </a:defRPr>
                </a:lvl9pPr>
              </a:lstStyle>
              <a:p>
                <a:pPr eaLnBrk="1" hangingPunct="1"/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50 </a:t>
                </a:r>
                <a:r>
                  <a:rPr lang="en-US" altLang="ja-JP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---</a:t>
                </a:r>
              </a:p>
            </p:txBody>
          </p:sp>
        </p:grpSp>
        <p:grpSp>
          <p:nvGrpSpPr>
            <p:cNvPr id="6" name="図形グループ 5"/>
            <p:cNvGrpSpPr/>
            <p:nvPr/>
          </p:nvGrpSpPr>
          <p:grpSpPr>
            <a:xfrm>
              <a:off x="5477754" y="788513"/>
              <a:ext cx="930831" cy="769347"/>
              <a:chOff x="5674350" y="1022926"/>
              <a:chExt cx="930831" cy="769347"/>
            </a:xfrm>
          </p:grpSpPr>
          <p:cxnSp>
            <p:nvCxnSpPr>
              <p:cNvPr id="10" name="直線コネクタ 9"/>
              <p:cNvCxnSpPr/>
              <p:nvPr/>
            </p:nvCxnSpPr>
            <p:spPr>
              <a:xfrm>
                <a:off x="5684592" y="1034398"/>
                <a:ext cx="0" cy="757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線コネクタ 43"/>
              <p:cNvCxnSpPr/>
              <p:nvPr/>
            </p:nvCxnSpPr>
            <p:spPr>
              <a:xfrm>
                <a:off x="6594974" y="1022926"/>
                <a:ext cx="0" cy="757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/>
              <p:cNvCxnSpPr/>
              <p:nvPr/>
            </p:nvCxnSpPr>
            <p:spPr>
              <a:xfrm flipV="1">
                <a:off x="5674350" y="1034400"/>
                <a:ext cx="921827" cy="10246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線コネクタ 56"/>
              <p:cNvCxnSpPr/>
              <p:nvPr/>
            </p:nvCxnSpPr>
            <p:spPr>
              <a:xfrm flipV="1">
                <a:off x="5683354" y="1780810"/>
                <a:ext cx="921827" cy="10246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図形グループ 53"/>
            <p:cNvGrpSpPr/>
            <p:nvPr/>
          </p:nvGrpSpPr>
          <p:grpSpPr>
            <a:xfrm>
              <a:off x="5476516" y="5047794"/>
              <a:ext cx="930831" cy="769347"/>
              <a:chOff x="5674350" y="1022926"/>
              <a:chExt cx="930831" cy="769347"/>
            </a:xfrm>
          </p:grpSpPr>
          <p:cxnSp>
            <p:nvCxnSpPr>
              <p:cNvPr id="55" name="直線コネクタ 54"/>
              <p:cNvCxnSpPr/>
              <p:nvPr/>
            </p:nvCxnSpPr>
            <p:spPr>
              <a:xfrm>
                <a:off x="5684592" y="1034398"/>
                <a:ext cx="0" cy="757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直線コネクタ 81"/>
              <p:cNvCxnSpPr/>
              <p:nvPr/>
            </p:nvCxnSpPr>
            <p:spPr>
              <a:xfrm>
                <a:off x="6594974" y="1022926"/>
                <a:ext cx="0" cy="757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直線コネクタ 82"/>
              <p:cNvCxnSpPr/>
              <p:nvPr/>
            </p:nvCxnSpPr>
            <p:spPr>
              <a:xfrm flipV="1">
                <a:off x="5674350" y="1034400"/>
                <a:ext cx="921827" cy="10246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直線コネクタ 83"/>
              <p:cNvCxnSpPr/>
              <p:nvPr/>
            </p:nvCxnSpPr>
            <p:spPr>
              <a:xfrm flipV="1">
                <a:off x="5683354" y="1780810"/>
                <a:ext cx="921827" cy="10246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図形グループ 84"/>
            <p:cNvGrpSpPr/>
            <p:nvPr/>
          </p:nvGrpSpPr>
          <p:grpSpPr>
            <a:xfrm>
              <a:off x="3806986" y="3204319"/>
              <a:ext cx="930831" cy="769347"/>
              <a:chOff x="5674350" y="1022926"/>
              <a:chExt cx="930831" cy="769347"/>
            </a:xfrm>
          </p:grpSpPr>
          <p:cxnSp>
            <p:nvCxnSpPr>
              <p:cNvPr id="86" name="直線コネクタ 85"/>
              <p:cNvCxnSpPr/>
              <p:nvPr/>
            </p:nvCxnSpPr>
            <p:spPr>
              <a:xfrm>
                <a:off x="5684592" y="1034398"/>
                <a:ext cx="0" cy="757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直線コネクタ 86"/>
              <p:cNvCxnSpPr/>
              <p:nvPr/>
            </p:nvCxnSpPr>
            <p:spPr>
              <a:xfrm>
                <a:off x="6594974" y="1022926"/>
                <a:ext cx="0" cy="757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線コネクタ 87"/>
              <p:cNvCxnSpPr/>
              <p:nvPr/>
            </p:nvCxnSpPr>
            <p:spPr>
              <a:xfrm flipV="1">
                <a:off x="5674350" y="1034400"/>
                <a:ext cx="921827" cy="10246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直線コネクタ 88"/>
              <p:cNvCxnSpPr/>
              <p:nvPr/>
            </p:nvCxnSpPr>
            <p:spPr>
              <a:xfrm flipV="1">
                <a:off x="5683354" y="1780810"/>
                <a:ext cx="921827" cy="10246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図形グループ 89"/>
            <p:cNvGrpSpPr/>
            <p:nvPr/>
          </p:nvGrpSpPr>
          <p:grpSpPr>
            <a:xfrm>
              <a:off x="3775019" y="5128535"/>
              <a:ext cx="930831" cy="769347"/>
              <a:chOff x="5674350" y="1022926"/>
              <a:chExt cx="930831" cy="769347"/>
            </a:xfrm>
          </p:grpSpPr>
          <p:cxnSp>
            <p:nvCxnSpPr>
              <p:cNvPr id="91" name="直線コネクタ 90"/>
              <p:cNvCxnSpPr/>
              <p:nvPr/>
            </p:nvCxnSpPr>
            <p:spPr>
              <a:xfrm>
                <a:off x="5684592" y="1034398"/>
                <a:ext cx="0" cy="757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直線コネクタ 91"/>
              <p:cNvCxnSpPr/>
              <p:nvPr/>
            </p:nvCxnSpPr>
            <p:spPr>
              <a:xfrm>
                <a:off x="6594974" y="1022926"/>
                <a:ext cx="0" cy="75787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線コネクタ 92"/>
              <p:cNvCxnSpPr/>
              <p:nvPr/>
            </p:nvCxnSpPr>
            <p:spPr>
              <a:xfrm flipV="1">
                <a:off x="5674350" y="1034400"/>
                <a:ext cx="921827" cy="10246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線コネクタ 93"/>
              <p:cNvCxnSpPr/>
              <p:nvPr/>
            </p:nvCxnSpPr>
            <p:spPr>
              <a:xfrm flipV="1">
                <a:off x="5683354" y="1780810"/>
                <a:ext cx="921827" cy="10246"/>
              </a:xfrm>
              <a:prstGeom prst="line">
                <a:avLst/>
              </a:prstGeom>
              <a:ln w="1905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" name="直線矢印コネクタ 8">
              <a:extLst>
                <a:ext uri="{FF2B5EF4-FFF2-40B4-BE49-F238E27FC236}">
                  <a16:creationId xmlns:a16="http://schemas.microsoft.com/office/drawing/2014/main" id="{85CFC86C-20F1-323E-7131-047EE3FC36E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20663" y="1088136"/>
              <a:ext cx="29260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矢印コネクタ 13">
              <a:extLst>
                <a:ext uri="{FF2B5EF4-FFF2-40B4-BE49-F238E27FC236}">
                  <a16:creationId xmlns:a16="http://schemas.microsoft.com/office/drawing/2014/main" id="{AE557BBA-8526-01D6-3D71-4B910222699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17615" y="3334512"/>
              <a:ext cx="29260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矢印コネクタ 14">
              <a:extLst>
                <a:ext uri="{FF2B5EF4-FFF2-40B4-BE49-F238E27FC236}">
                  <a16:creationId xmlns:a16="http://schemas.microsoft.com/office/drawing/2014/main" id="{60BE2ABF-3F57-C85E-A736-90E10C8BCF2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41999" y="5416296"/>
              <a:ext cx="292608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98442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</TotalTime>
  <Words>51</Words>
  <Application>Microsoft Office PowerPoint</Application>
  <PresentationFormat>画面に合わせる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長谷川 貴亮</dc:creator>
  <cp:lastModifiedBy>佐久間　理吏</cp:lastModifiedBy>
  <cp:revision>24</cp:revision>
  <cp:lastPrinted>2019-02-05T05:11:42Z</cp:lastPrinted>
  <dcterms:created xsi:type="dcterms:W3CDTF">2019-01-31T07:24:24Z</dcterms:created>
  <dcterms:modified xsi:type="dcterms:W3CDTF">2023-03-15T03:36:26Z</dcterms:modified>
</cp:coreProperties>
</file>